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100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sv-SE" altLang="zh-CN" smtClean="0"/>
              <a:t>Click to edit Master subtitle style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59791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69404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25471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0148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1625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009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3456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9506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6016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5978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sv-SE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0224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sv-SE" altLang="zh-CN" smtClean="0"/>
              <a:t>Click to edit Master title style</a:t>
            </a:r>
            <a:endParaRPr kumimoji="1"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6A44-EBEB-9E43-AD39-15BE737C5E36}" type="datetimeFigureOut">
              <a:rPr kumimoji="1" lang="zh-CN" altLang="en-US" smtClean="0"/>
              <a:t>2021/11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2EF6E-93AB-F74B-B9C4-CAE1F4CF44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314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021-07-27 11hr 18min 46sec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309" y="1045607"/>
            <a:ext cx="3419856" cy="2737104"/>
          </a:xfrm>
          <a:prstGeom prst="rect">
            <a:avLst/>
          </a:prstGeom>
        </p:spPr>
      </p:pic>
      <p:pic>
        <p:nvPicPr>
          <p:cNvPr id="3" name="Picture 2" descr="2021-07-27 11hr 22min 30sec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6027" y="1089630"/>
            <a:ext cx="3419856" cy="27371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47752" y="4125738"/>
            <a:ext cx="760185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/>
              <a:t>Figure S2. Full </a:t>
            </a:r>
            <a:r>
              <a:rPr kumimoji="1" lang="en-US" altLang="zh-CN" dirty="0" smtClean="0"/>
              <a:t>length original </a:t>
            </a:r>
            <a:r>
              <a:rPr kumimoji="1" lang="en-US" altLang="zh-CN" dirty="0" smtClean="0"/>
              <a:t>image of western blot analyses shown in Figure 2B &amp; C. On the left is the original western blot image and on the right is a photo of the membrane taken after ECL detection with protein ladder seen. These images are directly </a:t>
            </a:r>
            <a:r>
              <a:rPr kumimoji="1" lang="en-US" altLang="zh-CN" dirty="0" smtClean="0"/>
              <a:t>ex</a:t>
            </a:r>
            <a:r>
              <a:rPr kumimoji="1" lang="en-US" altLang="zh-CN" dirty="0" smtClean="0"/>
              <a:t>ported </a:t>
            </a:r>
            <a:r>
              <a:rPr kumimoji="1" lang="en-US" altLang="zh-CN" dirty="0" smtClean="0"/>
              <a:t>from the software (Bio-Rad Image </a:t>
            </a:r>
            <a:r>
              <a:rPr kumimoji="1" lang="en-US" altLang="zh-CN" dirty="0" smtClean="0"/>
              <a:t>lab version 5.2.1) </a:t>
            </a:r>
            <a:r>
              <a:rPr kumimoji="1" lang="en-US" altLang="zh-CN" dirty="0" smtClean="0"/>
              <a:t>without any manipulation. The membrane was cut into two pieces after protein transfer, one was used for anti-his-tag antibody and the other one was used for anti-TK1 antibody. They were put together just before ECL detection. The membrane is outlined with black lines.</a:t>
            </a:r>
            <a:endParaRPr kumimoji="1" lang="en-US" altLang="zh-CN" dirty="0"/>
          </a:p>
        </p:txBody>
      </p:sp>
      <p:sp>
        <p:nvSpPr>
          <p:cNvPr id="7" name="Rectangle 6"/>
          <p:cNvSpPr/>
          <p:nvPr/>
        </p:nvSpPr>
        <p:spPr>
          <a:xfrm>
            <a:off x="967566" y="1572439"/>
            <a:ext cx="2902697" cy="22102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8" name="Rectangle 7"/>
          <p:cNvSpPr/>
          <p:nvPr/>
        </p:nvSpPr>
        <p:spPr>
          <a:xfrm>
            <a:off x="4869354" y="1613959"/>
            <a:ext cx="2902697" cy="22102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2416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09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-presentation</vt:lpstr>
    </vt:vector>
  </TitlesOfParts>
  <Company>S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ya Wang</dc:creator>
  <cp:lastModifiedBy>Liya Wang</cp:lastModifiedBy>
  <cp:revision>6</cp:revision>
  <dcterms:created xsi:type="dcterms:W3CDTF">2021-11-12T12:09:54Z</dcterms:created>
  <dcterms:modified xsi:type="dcterms:W3CDTF">2021-11-12T13:18:56Z</dcterms:modified>
</cp:coreProperties>
</file>